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  <p:sldId id="289" r:id="rId38"/>
    <p:sldId id="290" r:id="rId39"/>
    <p:sldId id="291" r:id="rId40"/>
    <p:sldId id="292" r:id="rId41"/>
    <p:sldId id="293" r:id="rId42"/>
    <p:sldId id="294" r:id="rId43"/>
    <p:sldId id="295" r:id="rId44"/>
    <p:sldId id="296" r:id="rId45"/>
    <p:sldId id="297" r:id="rId4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87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328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slide" Target="slides/slide38.xml"/><Relationship Id="rId47" Type="http://schemas.openxmlformats.org/officeDocument/2006/relationships/presProps" Target="presProps.xml"/><Relationship Id="rId50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slide" Target="slides/slide42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41" Type="http://schemas.openxmlformats.org/officeDocument/2006/relationships/slide" Target="slides/slide37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slide" Target="slides/slide4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49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slide" Target="slides/slide40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slide" Target="slides/slide39.xml"/><Relationship Id="rId48" Type="http://schemas.openxmlformats.org/officeDocument/2006/relationships/viewProps" Target="viewProps.xml"/><Relationship Id="rId8" Type="http://schemas.openxmlformats.org/officeDocument/2006/relationships/slide" Target="slides/slide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90EE9-50AD-4311-A360-6D88BD8658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148044-8DE8-4BD3-8DE6-C75C2F5DFE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A6FD8-B527-42D3-8E7C-72AF00864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2778D-9C83-41AD-B044-CB2FF257D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4F0E7C-AFCA-4AC4-A63D-CC886E1F0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9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B433A-FE9C-4710-AAC0-CFF1B224D5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F87C21-D7A0-4CCB-826D-18D199CD1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5128D-4CC8-4969-9313-116C6CC48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21B1B3-1B36-441A-BD60-5E223340D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31D14-490C-4BD8-A6A8-5989FD99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759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97A3A9-388D-412C-B78D-DDEAB6BA88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4E6BF-B8C3-4965-B3BF-F2315C4259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70C97-9C88-4371-8C8E-A89A8FE23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100A99-FE8D-44BB-8BF3-D65BE4190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36BE6-7898-4514-ACC1-B2DD3FF04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13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7F934-4EFB-4F1A-B0DF-FEC666EB84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036DBE-D944-422B-A4F5-D493412A03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3ABEEA-F5E3-4AC4-B64D-C5300A5FA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15DDB-559F-4058-BFD5-2210450A3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B8214-E259-411F-90C5-3D857191A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8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25DAC-8930-41F5-BDE2-D44CA44AD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EE25FA-8B9C-4F61-94EB-0057651D4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788CA-B067-40FF-9BB1-7CE8388A4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498D8-7767-45AB-9B96-3CACFF122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22675-8B59-4D74-A065-39CCEF7FE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077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200F1-9CDE-4444-BBAE-6D7A4CED2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6B68E-AD2F-432B-BF06-C695A760D7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EE5EA0-1CAC-4D56-91B2-1BE412862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657C4-C980-4D84-9100-2EB78FB72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0F931-BBEF-40FC-90D8-60266E071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9543D-65E6-431F-BCD2-530C47CB6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6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BF01B-E2A4-4EAD-947D-CA88CA109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709BE3-290D-40F2-92E4-05DCDFAD93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C9C1B9-4042-422B-86B1-954B4B8C4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65E13A-75D0-48C7-A50F-A62300845C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E310A0-1BCF-4BB1-A3A8-9FA993A889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FFD16-3221-4912-81A4-20989CF86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439BFD-2F8A-420D-98C2-6E1D1FF75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7AC0A5-39FD-4F59-A02A-AC77F4F80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81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27748-1482-4303-9AF8-E97724B9B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BB4A3-2409-4DD8-970A-2D23EDB28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F6DA8D-08D0-4CDB-81AD-4E625AC83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FFA867-262F-4AA0-B4B4-5D7279A37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77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424663-E24F-4187-86D7-711B85165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EECFC5-4367-4ADC-A209-E5575A9BF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34E3ED-1F02-42C0-AD7F-AC2EBEC71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93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A0065-B281-460A-9116-7BE92688A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60AD1-044B-4146-8A2D-69F0046A9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68F3E3-1AC5-4593-BF1A-237F71792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40CDDF-2C2A-45DD-BEF7-F533CF748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77004A-44FE-4127-83AD-D52FE07EC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356837-BF82-46D4-9CCB-933756011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2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8B7BB-828B-4116-9A3A-33CDECF6A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FECBAE-AB2B-4041-99DE-66E3AACDC0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6F0C5E-E67B-4B20-9C7C-D54BFAADE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96A703-F743-4935-9CEC-A078A9A75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A02116-0695-4A1F-93F3-3D0336E82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2A82F3-B99C-454F-8B10-0D163F891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96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884E9C-9ABE-4DCA-A5A8-9FE551EFF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AB5AC-C87A-46ED-AA83-848B8E0AA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67F78-BCDA-4B04-8E69-588398A5EE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020622-234B-4650-B137-AD8822ECE9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CD29F-6AF3-4D79-8621-0731DC7246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61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Text&#10;&#10;Description automatically generated">
            <a:extLst>
              <a:ext uri="{FF2B5EF4-FFF2-40B4-BE49-F238E27FC236}">
                <a16:creationId xmlns:a16="http://schemas.microsoft.com/office/drawing/2014/main" id="{83296F22-E3CB-49B9-BC1B-8694FF48E7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2564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human skull&#10;&#10;Description automatically generated with low confidence">
            <a:extLst>
              <a:ext uri="{FF2B5EF4-FFF2-40B4-BE49-F238E27FC236}">
                <a16:creationId xmlns:a16="http://schemas.microsoft.com/office/drawing/2014/main" id="{6B65A952-1EA3-4251-ACFD-C980404BAE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0691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ED2AB56A-D1E0-41C5-A7C1-9753CFA21E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29783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indoor&#10;&#10;Description automatically generated">
            <a:extLst>
              <a:ext uri="{FF2B5EF4-FFF2-40B4-BE49-F238E27FC236}">
                <a16:creationId xmlns:a16="http://schemas.microsoft.com/office/drawing/2014/main" id="{3B68A01E-2BEA-4099-9100-BE7021A0EA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6150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C6401649-574D-44D0-AA13-879473C645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8865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human brain&#10;&#10;Description automatically generated with low confidence">
            <a:extLst>
              <a:ext uri="{FF2B5EF4-FFF2-40B4-BE49-F238E27FC236}">
                <a16:creationId xmlns:a16="http://schemas.microsoft.com/office/drawing/2014/main" id="{A85999C0-3FBA-4DC2-97BF-C5A60B5800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4997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human brain&#10;&#10;Description automatically generated with medium confidence">
            <a:extLst>
              <a:ext uri="{FF2B5EF4-FFF2-40B4-BE49-F238E27FC236}">
                <a16:creationId xmlns:a16="http://schemas.microsoft.com/office/drawing/2014/main" id="{6A4376CC-553F-4CF6-8080-97223A1A65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0475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human brain&#10;&#10;Description automatically generated with low confidence">
            <a:extLst>
              <a:ext uri="{FF2B5EF4-FFF2-40B4-BE49-F238E27FC236}">
                <a16:creationId xmlns:a16="http://schemas.microsoft.com/office/drawing/2014/main" id="{326F4A19-1A4B-4AE3-A00D-74E3444013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5402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human skull&#10;&#10;Description automatically generated with low confidence">
            <a:extLst>
              <a:ext uri="{FF2B5EF4-FFF2-40B4-BE49-F238E27FC236}">
                <a16:creationId xmlns:a16="http://schemas.microsoft.com/office/drawing/2014/main" id="{42A7DF98-F9B9-4637-919A-7CCC5A6C20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9365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538E6CA-2E5E-42BF-B035-3E1AB0BDC3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920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human brain&#10;&#10;Description automatically generated with low confidence">
            <a:extLst>
              <a:ext uri="{FF2B5EF4-FFF2-40B4-BE49-F238E27FC236}">
                <a16:creationId xmlns:a16="http://schemas.microsoft.com/office/drawing/2014/main" id="{571CA9BA-7760-4850-8614-41F822086D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40698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011F6702-359D-4B41-AA5B-77A9A6F9E6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0955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BF89B239-5DC5-4E19-AE79-6DE3565CE7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4862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79FE0DDE-D667-4A00-A472-945CA34217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7256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39359EB-80A6-4A46-B931-E9FB5A08BB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36917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66886F41-3652-4E41-B997-955BE5A526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2687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6EEB96A4-5BF8-41F6-91F6-46B3996290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2492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A2BF02F2-9F26-4E20-AC0F-39148318A5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63340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8AE64E7F-4F65-4E0B-941F-934CFD359E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6279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36300DAD-A238-4D76-8C21-3FBA796470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4754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69692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86994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5235E471-2E33-4FC9-BC43-3414B73F14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126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38155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97538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46271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057145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61554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77674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79874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959876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31960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29143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47D93FAA-2883-485B-A401-4A54FFD9CA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0751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59676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74871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18779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E40AAC0-F333-43AC-9CA6-4B3172A65C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5131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7E2CEDD7-2D84-45DE-8008-66AFE6CA90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7173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9C2CE3C7-F249-4C8E-A4BC-79CF1D09A8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210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the brain&#10;&#10;Description automatically generated with low confidence">
            <a:extLst>
              <a:ext uri="{FF2B5EF4-FFF2-40B4-BE49-F238E27FC236}">
                <a16:creationId xmlns:a16="http://schemas.microsoft.com/office/drawing/2014/main" id="{FF1102E5-5876-4906-9535-044402E6A6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79788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the human brain&#10;&#10;Description automatically generated with low confidence">
            <a:extLst>
              <a:ext uri="{FF2B5EF4-FFF2-40B4-BE49-F238E27FC236}">
                <a16:creationId xmlns:a16="http://schemas.microsoft.com/office/drawing/2014/main" id="{385BECB4-A9F7-4B4E-8D1E-4F444D0AAE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8109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CC25D49F2F4B4489B9721A466FDF4D" ma:contentTypeVersion="8" ma:contentTypeDescription="Create a new document." ma:contentTypeScope="" ma:versionID="71e9c98e0f852595cf47c6f661845709">
  <xsd:schema xmlns:xsd="http://www.w3.org/2001/XMLSchema" xmlns:xs="http://www.w3.org/2001/XMLSchema" xmlns:p="http://schemas.microsoft.com/office/2006/metadata/properties" xmlns:ns2="8fddeaa3-4732-4488-9db6-a053d8348361" xmlns:ns3="1e1c5aca-6f1d-4e22-8716-d44e9b47b6c2" targetNamespace="http://schemas.microsoft.com/office/2006/metadata/properties" ma:root="true" ma:fieldsID="9e6f634192e81de9c62830f3e2e111b9" ns2:_="" ns3:_="">
    <xsd:import namespace="8fddeaa3-4732-4488-9db6-a053d8348361"/>
    <xsd:import namespace="1e1c5aca-6f1d-4e22-8716-d44e9b47b6c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fddeaa3-4732-4488-9db6-a053d834836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1c5aca-6f1d-4e22-8716-d44e9b47b6c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C797932-DEEC-462E-A3CC-61C320572AC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fddeaa3-4732-4488-9db6-a053d8348361"/>
    <ds:schemaRef ds:uri="1e1c5aca-6f1d-4e22-8716-d44e9b47b6c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337D6D2-FE04-4C2C-AC41-C1CAE7C997EA}">
  <ds:schemaRefs>
    <ds:schemaRef ds:uri="http://purl.org/dc/elements/1.1/"/>
    <ds:schemaRef ds:uri="http://schemas.microsoft.com/office/2006/metadata/properties"/>
    <ds:schemaRef ds:uri="1e1c5aca-6f1d-4e22-8716-d44e9b47b6c2"/>
    <ds:schemaRef ds:uri="8fddeaa3-4732-4488-9db6-a053d8348361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C1DE9DF0-093E-42D9-B64B-2671DD9F2B4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0</Words>
  <PresentationFormat>Widescreen</PresentationFormat>
  <Paragraphs>0</Paragraphs>
  <Slides>4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2</vt:i4>
      </vt:variant>
    </vt:vector>
  </HeadingPairs>
  <TitlesOfParts>
    <vt:vector size="4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9-05T17:17:40Z</dcterms:created>
  <dcterms:modified xsi:type="dcterms:W3CDTF">2021-09-07T14:15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CC25D49F2F4B4489B9721A466FDF4D</vt:lpwstr>
  </property>
</Properties>
</file>